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93AF6AB-9FA0-7C4F-A4F1-3F420F3D3ADE}" v="2" dt="2023-06-08T18:44:06.93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6190"/>
  </p:normalViewPr>
  <p:slideViewPr>
    <p:cSldViewPr snapToGrid="0" snapToObjects="1">
      <p:cViewPr varScale="1">
        <p:scale>
          <a:sx n="123" d="100"/>
          <a:sy n="123" d="100"/>
        </p:scale>
        <p:origin x="6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yutaro Makino" userId="d3a9dc3dd267b724" providerId="LiveId" clId="{593AF6AB-9FA0-7C4F-A4F1-3F420F3D3ADE}"/>
    <pc:docChg chg="undo custSel modSld">
      <pc:chgData name="Ryutaro Makino" userId="d3a9dc3dd267b724" providerId="LiveId" clId="{593AF6AB-9FA0-7C4F-A4F1-3F420F3D3ADE}" dt="2023-06-08T18:45:05.011" v="14" actId="1076"/>
      <pc:docMkLst>
        <pc:docMk/>
      </pc:docMkLst>
      <pc:sldChg chg="addSp delSp modSp mod">
        <pc:chgData name="Ryutaro Makino" userId="d3a9dc3dd267b724" providerId="LiveId" clId="{593AF6AB-9FA0-7C4F-A4F1-3F420F3D3ADE}" dt="2023-06-08T18:45:05.011" v="14" actId="1076"/>
        <pc:sldMkLst>
          <pc:docMk/>
          <pc:sldMk cId="1570366644" sldId="259"/>
        </pc:sldMkLst>
        <pc:spChg chg="add mod">
          <ac:chgData name="Ryutaro Makino" userId="d3a9dc3dd267b724" providerId="LiveId" clId="{593AF6AB-9FA0-7C4F-A4F1-3F420F3D3ADE}" dt="2023-06-08T18:45:05.011" v="14" actId="1076"/>
          <ac:spMkLst>
            <pc:docMk/>
            <pc:sldMk cId="1570366644" sldId="259"/>
            <ac:spMk id="2" creationId="{EBBC0C85-1EE5-BDA0-526E-B354913F251D}"/>
          </ac:spMkLst>
        </pc:spChg>
        <pc:spChg chg="mod">
          <ac:chgData name="Ryutaro Makino" userId="d3a9dc3dd267b724" providerId="LiveId" clId="{593AF6AB-9FA0-7C4F-A4F1-3F420F3D3ADE}" dt="2023-06-08T18:38:43.817" v="5" actId="207"/>
          <ac:spMkLst>
            <pc:docMk/>
            <pc:sldMk cId="1570366644" sldId="259"/>
            <ac:spMk id="5" creationId="{4DA8EC53-246E-0604-41A6-C5895E5D3A0C}"/>
          </ac:spMkLst>
        </pc:spChg>
        <pc:spChg chg="mod">
          <ac:chgData name="Ryutaro Makino" userId="d3a9dc3dd267b724" providerId="LiveId" clId="{593AF6AB-9FA0-7C4F-A4F1-3F420F3D3ADE}" dt="2023-06-08T18:38:40.987" v="4" actId="207"/>
          <ac:spMkLst>
            <pc:docMk/>
            <pc:sldMk cId="1570366644" sldId="259"/>
            <ac:spMk id="7" creationId="{9478B630-FDA9-C95B-89C4-C22ADAA9B5ED}"/>
          </ac:spMkLst>
        </pc:spChg>
        <pc:spChg chg="del mod">
          <ac:chgData name="Ryutaro Makino" userId="d3a9dc3dd267b724" providerId="LiveId" clId="{593AF6AB-9FA0-7C4F-A4F1-3F420F3D3ADE}" dt="2023-06-08T18:44:59.229" v="12" actId="478"/>
          <ac:spMkLst>
            <pc:docMk/>
            <pc:sldMk cId="1570366644" sldId="259"/>
            <ac:spMk id="10" creationId="{3B335530-A560-8D44-EC1E-6DBD37D5604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ADC9C4-FE49-33F1-3B05-916B826D6C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2867D79-547D-EA9A-1869-299CA9B02E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41ABAF-9F42-3D3F-07AB-7788090EF3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55E88-7C6C-F44D-875A-BB7167FDB6E1}" type="datetimeFigureOut">
              <a:rPr kumimoji="1" lang="ja-JP" altLang="en-US" smtClean="0"/>
              <a:t>2023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2C2AE44-7D93-F36E-4A16-6B0EE6C189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0D9718-AE48-41F4-3172-002081EC34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F3A5A-89FE-B245-AD7D-4D7510064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0972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EC23FE-FE05-BCF6-040F-1941F07D6F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4ADE6B1-DB5A-33F3-893C-8F76DD8423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BBD53A-111B-8B9B-9C43-20DF23E567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55E88-7C6C-F44D-875A-BB7167FDB6E1}" type="datetimeFigureOut">
              <a:rPr kumimoji="1" lang="ja-JP" altLang="en-US" smtClean="0"/>
              <a:t>2023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FB02AD-30CA-E226-4176-E693368130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E442C4A-2EC8-05DC-57A9-92C9FA90F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F3A5A-89FE-B245-AD7D-4D7510064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0969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3B7CFA5-404E-4322-F49E-CE2C2FADE0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BF8B1BC-BC4E-965A-9830-85D733D273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E1423E-1098-FFC9-8863-89BDDB1708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55E88-7C6C-F44D-875A-BB7167FDB6E1}" type="datetimeFigureOut">
              <a:rPr kumimoji="1" lang="ja-JP" altLang="en-US" smtClean="0"/>
              <a:t>2023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EAA6B39-FC7D-9635-E722-2C1417472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83A9DA-1A58-0428-AD65-CED283B51A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F3A5A-89FE-B245-AD7D-4D7510064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8352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F6958F-8A49-28C8-12F9-1E0D5DED31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FD2CE7B-1B44-7DF4-2307-E6D565FB54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BE32704-28F5-3AE7-9F02-068D7E5B8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55E88-7C6C-F44D-875A-BB7167FDB6E1}" type="datetimeFigureOut">
              <a:rPr kumimoji="1" lang="ja-JP" altLang="en-US" smtClean="0"/>
              <a:t>2023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78613A-B749-0598-06CF-223E00369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D0DE7D2-CF4D-5B21-F51D-73F97EC916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F3A5A-89FE-B245-AD7D-4D7510064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9262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1EB4F4-F444-DEE7-A7B3-1064BDD1B5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513DD84-F79F-B087-EBB4-15747B25D7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8D48DB-A68B-16EF-F6E0-1037D16A0E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55E88-7C6C-F44D-875A-BB7167FDB6E1}" type="datetimeFigureOut">
              <a:rPr kumimoji="1" lang="ja-JP" altLang="en-US" smtClean="0"/>
              <a:t>2023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AD22A37-F5FE-2D9D-170A-239B67DB16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FDD0BE0-6C06-8405-0C09-D3EAD80C7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F3A5A-89FE-B245-AD7D-4D7510064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39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CE3EAF-BDA6-7FFB-DBA3-7F2AFD3664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5933631-1AC9-EFCA-8514-C0DC154E00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FDE109C-6DA0-3CF7-EFA5-EE607657D9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F9CF575-0827-AB38-057D-1FA57B03D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55E88-7C6C-F44D-875A-BB7167FDB6E1}" type="datetimeFigureOut">
              <a:rPr kumimoji="1" lang="ja-JP" altLang="en-US" smtClean="0"/>
              <a:t>2023/6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0B51505-CF1E-4F24-FD1D-B64E95A582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E7F4386-6383-57D7-2B1F-752872701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F3A5A-89FE-B245-AD7D-4D7510064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2355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6A0228-E642-C898-FE3D-6AD605B285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299AF8A-714C-F20D-DF2E-6456C1F7A0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80A7DEE-7F43-CAE0-1C1B-ECE0CAF55C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A8B2F60-2EB9-750B-D602-6C50828448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87B46BC-5FDE-5021-22B2-CF2A3A7D50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FD97101-652E-14E2-AF7F-75AA071D86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55E88-7C6C-F44D-875A-BB7167FDB6E1}" type="datetimeFigureOut">
              <a:rPr kumimoji="1" lang="ja-JP" altLang="en-US" smtClean="0"/>
              <a:t>2023/6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62A4E19-C700-2A1D-23F5-DE2D53468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DFF99E5-3736-24FB-FCB3-C9D75421D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F3A5A-89FE-B245-AD7D-4D7510064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3678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DBC2C8-7942-9E9E-A077-85B814FB17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41A5429-619B-0CD4-E40B-76E034455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55E88-7C6C-F44D-875A-BB7167FDB6E1}" type="datetimeFigureOut">
              <a:rPr kumimoji="1" lang="ja-JP" altLang="en-US" smtClean="0"/>
              <a:t>2023/6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EC0F993-5809-71B1-ED9F-56F6F10A9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09073C5-2EBF-333B-607E-2BE265BDE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F3A5A-89FE-B245-AD7D-4D7510064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19099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D5ECD68-7C3C-80BE-B15D-39BA3C4EC2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55E88-7C6C-F44D-875A-BB7167FDB6E1}" type="datetimeFigureOut">
              <a:rPr kumimoji="1" lang="ja-JP" altLang="en-US" smtClean="0"/>
              <a:t>2023/6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76D6005-0F40-D9EA-FC94-298F3D8A3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56566B2-B398-2EB7-AA62-25143079C3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F3A5A-89FE-B245-AD7D-4D7510064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0992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5F33DEF-FBBE-DED0-C24E-73B329BE98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0ED6CAB-BB0A-3A5F-92F7-B4622DEB06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F64E365-A43D-1A22-F953-D6ADC2036B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3FC3F74-E829-3DC3-9FC4-BB19EAEC2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55E88-7C6C-F44D-875A-BB7167FDB6E1}" type="datetimeFigureOut">
              <a:rPr kumimoji="1" lang="ja-JP" altLang="en-US" smtClean="0"/>
              <a:t>2023/6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C20B7E7-A773-F57F-C873-21DD132640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3EBB64C-BA50-5913-2390-2D974785A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F3A5A-89FE-B245-AD7D-4D7510064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092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FF26A2-A51F-D97B-4828-9DE10EDDC4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2E98EA4-AFAD-3C0A-52DD-13AB825B9A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284CCA6-0BBE-BC6E-3DF7-91D8635B5C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8A7AAAD-7A21-317B-42D1-B79EFE003B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55E88-7C6C-F44D-875A-BB7167FDB6E1}" type="datetimeFigureOut">
              <a:rPr kumimoji="1" lang="ja-JP" altLang="en-US" smtClean="0"/>
              <a:t>2023/6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34FDD8A-4A20-F5BF-2F3A-62D01773ED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1C760A7-F632-B82F-FFE0-E649723567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F3A5A-89FE-B245-AD7D-4D7510064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3344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D38D246-62D0-A421-3C0D-55CAEF30A4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8F0771A-E622-F07E-2451-2D05C39C59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E1C5436-84E7-1C96-99DA-F4607F9A58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755E88-7C6C-F44D-875A-BB7167FDB6E1}" type="datetimeFigureOut">
              <a:rPr kumimoji="1" lang="ja-JP" altLang="en-US" smtClean="0"/>
              <a:t>2023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172ABA3-0013-7067-224A-1945560B13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262FB17-0B7C-D8F6-7C73-F0740CE061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3F3A5A-89FE-B245-AD7D-4D75100646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1228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ACB1B4D-DFF6-CD03-F3F9-A504AB430A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27414" y="2179285"/>
            <a:ext cx="3536126" cy="249943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DA8EC53-246E-0604-41A6-C5895E5D3A0C}"/>
              </a:ext>
            </a:extLst>
          </p:cNvPr>
          <p:cNvSpPr txBox="1"/>
          <p:nvPr/>
        </p:nvSpPr>
        <p:spPr>
          <a:xfrm>
            <a:off x="8313878" y="2958777"/>
            <a:ext cx="16866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p=0.008, Log-rank test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A652B90E-6774-5169-94E0-53F793DF0C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81175" y="2192354"/>
            <a:ext cx="3540900" cy="2473292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478B630-FDA9-C95B-89C4-C22ADAA9B5ED}"/>
              </a:ext>
            </a:extLst>
          </p:cNvPr>
          <p:cNvSpPr txBox="1"/>
          <p:nvPr/>
        </p:nvSpPr>
        <p:spPr>
          <a:xfrm>
            <a:off x="4357807" y="2971955"/>
            <a:ext cx="16866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p=0.004, Log-rank test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724CC09-9ED2-6DC1-2917-76AD21228B69}"/>
              </a:ext>
            </a:extLst>
          </p:cNvPr>
          <p:cNvSpPr txBox="1"/>
          <p:nvPr/>
        </p:nvSpPr>
        <p:spPr>
          <a:xfrm>
            <a:off x="2477649" y="1761797"/>
            <a:ext cx="34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DFE5246-3BE7-1D6A-8392-204BF0171822}"/>
              </a:ext>
            </a:extLst>
          </p:cNvPr>
          <p:cNvSpPr txBox="1"/>
          <p:nvPr/>
        </p:nvSpPr>
        <p:spPr>
          <a:xfrm>
            <a:off x="6323827" y="1787852"/>
            <a:ext cx="43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B</a:t>
            </a:r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BBC0C85-1EE5-BDA0-526E-B354913F251D}"/>
              </a:ext>
            </a:extLst>
          </p:cNvPr>
          <p:cNvSpPr txBox="1"/>
          <p:nvPr/>
        </p:nvSpPr>
        <p:spPr>
          <a:xfrm>
            <a:off x="351135" y="5291349"/>
            <a:ext cx="1154187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2. Differences in overall survival (OS) based on imaging findings. (A) Group II had a poorer prognosis compared to groups I, III, and IV. (B) Group III had a more favorable prognosis compared to groups I, II, and IV.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03666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5</TotalTime>
  <Words>69</Words>
  <Application>Microsoft Macintosh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牧野　隆太郎</dc:creator>
  <cp:lastModifiedBy>牧野　隆太郎</cp:lastModifiedBy>
  <cp:revision>7</cp:revision>
  <dcterms:created xsi:type="dcterms:W3CDTF">2022-05-10T03:30:32Z</dcterms:created>
  <dcterms:modified xsi:type="dcterms:W3CDTF">2023-06-08T18:45:05Z</dcterms:modified>
</cp:coreProperties>
</file>